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10.docx" ContentType="application/vnd.openxmlformats-officedocument.wordprocessingml.document"/>
  <Override PartName="/ppt/embeddings/oleObject4.docx" ContentType="application/vnd.openxmlformats-officedocument.wordprocessingml.documen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media/image5.png" ContentType="image/png"/>
  <Override PartName="/ppt/media/image6.png" ContentType="image/png"/>
  <Override PartName="/ppt/media/image10.wmf" ContentType="image/x-wmf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1206400" cy="27432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2560320" y="1094400"/>
            <a:ext cx="46085400" cy="4580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1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2560320" y="6418800"/>
            <a:ext cx="4608540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2560320" y="14729040"/>
            <a:ext cx="4608540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2560320" y="1094400"/>
            <a:ext cx="46085400" cy="4580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1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2560320" y="6418800"/>
            <a:ext cx="2248956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26174880" y="6418800"/>
            <a:ext cx="2248956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/>
          </p:nvPr>
        </p:nvSpPr>
        <p:spPr>
          <a:xfrm>
            <a:off x="2560320" y="14729040"/>
            <a:ext cx="2248956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5"/>
          <p:cNvSpPr>
            <a:spLocks noGrp="1"/>
          </p:cNvSpPr>
          <p:nvPr>
            <p:ph/>
          </p:nvPr>
        </p:nvSpPr>
        <p:spPr>
          <a:xfrm>
            <a:off x="26174880" y="14729040"/>
            <a:ext cx="2248956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560320" y="1094400"/>
            <a:ext cx="46085400" cy="4580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1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60320" y="6418800"/>
            <a:ext cx="1483920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8141840" y="6418800"/>
            <a:ext cx="1483920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3723360" y="6418800"/>
            <a:ext cx="1483920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560320" y="14729040"/>
            <a:ext cx="1483920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" name="PlaceHolder 6"/>
          <p:cNvSpPr>
            <a:spLocks noGrp="1"/>
          </p:cNvSpPr>
          <p:nvPr>
            <p:ph/>
          </p:nvPr>
        </p:nvSpPr>
        <p:spPr>
          <a:xfrm>
            <a:off x="18141840" y="14729040"/>
            <a:ext cx="1483920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7"/>
          <p:cNvSpPr>
            <a:spLocks noGrp="1"/>
          </p:cNvSpPr>
          <p:nvPr>
            <p:ph/>
          </p:nvPr>
        </p:nvSpPr>
        <p:spPr>
          <a:xfrm>
            <a:off x="33723360" y="14729040"/>
            <a:ext cx="1483920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560320" y="1094400"/>
            <a:ext cx="46085400" cy="4580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1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subTitle"/>
          </p:nvPr>
        </p:nvSpPr>
        <p:spPr>
          <a:xfrm>
            <a:off x="2560320" y="6418800"/>
            <a:ext cx="46085400" cy="159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2560320" y="1094400"/>
            <a:ext cx="46085400" cy="4580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1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/>
          </p:nvPr>
        </p:nvSpPr>
        <p:spPr>
          <a:xfrm>
            <a:off x="2560320" y="6418800"/>
            <a:ext cx="46085400" cy="159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2560320" y="1094400"/>
            <a:ext cx="46085400" cy="4580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1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2560320" y="6418800"/>
            <a:ext cx="22489560" cy="159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/>
          </p:nvPr>
        </p:nvSpPr>
        <p:spPr>
          <a:xfrm>
            <a:off x="26174880" y="6418800"/>
            <a:ext cx="22489560" cy="159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560320" y="1094400"/>
            <a:ext cx="46085400" cy="4580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11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subTitle"/>
          </p:nvPr>
        </p:nvSpPr>
        <p:spPr>
          <a:xfrm>
            <a:off x="2560320" y="1094400"/>
            <a:ext cx="46085400" cy="2123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560320" y="1094400"/>
            <a:ext cx="46085400" cy="4580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1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60320" y="6418800"/>
            <a:ext cx="2248956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6174880" y="6418800"/>
            <a:ext cx="22489560" cy="159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" name="PlaceHolder 4"/>
          <p:cNvSpPr>
            <a:spLocks noGrp="1"/>
          </p:cNvSpPr>
          <p:nvPr>
            <p:ph/>
          </p:nvPr>
        </p:nvSpPr>
        <p:spPr>
          <a:xfrm>
            <a:off x="2560320" y="14729040"/>
            <a:ext cx="2248956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2560320" y="1094400"/>
            <a:ext cx="46085400" cy="4580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1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2560320" y="6418800"/>
            <a:ext cx="22489560" cy="159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26174880" y="6418800"/>
            <a:ext cx="2248956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26174880" y="14729040"/>
            <a:ext cx="2248956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2560320" y="1094400"/>
            <a:ext cx="46085400" cy="4580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1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2560320" y="6418800"/>
            <a:ext cx="2248956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26174880" y="6418800"/>
            <a:ext cx="2248956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2560320" y="14729040"/>
            <a:ext cx="46085400" cy="7588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2306520"/>
                <a:tab algn="l" pos="4613400"/>
                <a:tab algn="l" pos="6919920"/>
                <a:tab algn="l" pos="9226440"/>
              </a:tabLst>
            </a:pPr>
            <a:endParaRPr b="0" lang="en-US" sz="8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464f60"/>
            </a:gs>
            <a:gs pos="100000">
              <a:srgbClr val="99acd2"/>
            </a:gs>
          </a:gsLst>
          <a:path path="rect">
            <a:fillToRect l="50000" t="50000" r="50000" b="50000"/>
          </a:path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package" Target="../embeddings/oleObject4.docx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package" Target="../embeddings/oleObject10.docx"/><Relationship Id="rId20" Type="http://schemas.openxmlformats.org/officeDocument/2006/relationships/image" Target="../media/image10.wmf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464f60"/>
            </a:gs>
            <a:gs pos="100000">
              <a:srgbClr val="99acd2"/>
            </a:gs>
          </a:gsLst>
          <a:path path="rect">
            <a:fillToRect l="50000" t="50000" r="50000" b="50000"/>
          </a:path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"/>
          <p:cNvSpPr/>
          <p:nvPr/>
        </p:nvSpPr>
        <p:spPr>
          <a:xfrm>
            <a:off x="8298000" y="404640"/>
            <a:ext cx="34610400" cy="3718440"/>
          </a:xfrm>
          <a:prstGeom prst="rect">
            <a:avLst/>
          </a:prstGeom>
          <a:solidFill>
            <a:srgbClr val="ffff99"/>
          </a:solidFill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1200" rIns="61200" tIns="30600" bIns="306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REPRESENTATIVENESS IN eHEALTH PROGRAMS:  FACTORS RELATED TO RECRUITMENT, PARTICIPATION, 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AND RETENTION IN AN INTERNET WEIGHT LOSS STUDY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R.E. Glasgow, Ph.D.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1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; Candace C. Nelson, M.A.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1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; Kathleen A. Kearney, Ph.D.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2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; Kevin J. Wildenhaus, Ph.D.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3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; Robert J. Reid, M.D., Ph.D.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4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; 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Al Zielke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3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; Debra Ritzwoller, Ph.D.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1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;  Mick Couper, Ph.D.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5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; Victor J. Strecher, Ph.D., M.P.H.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5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; Beverly Green, M.D., M.P.H.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4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612720"/>
                <a:tab algn="l" pos="1225440"/>
                <a:tab algn="l" pos="1838160"/>
                <a:tab algn="l" pos="2451240"/>
                <a:tab algn="l" pos="3063960"/>
                <a:tab algn="l" pos="3676680"/>
                <a:tab algn="l" pos="4289400"/>
                <a:tab algn="l" pos="4902120"/>
                <a:tab algn="l" pos="5514840"/>
                <a:tab algn="l" pos="6127920"/>
                <a:tab algn="l" pos="6740640"/>
                <a:tab algn="l" pos="7353360"/>
                <a:tab algn="l" pos="7966080"/>
                <a:tab algn="l" pos="8578800"/>
                <a:tab algn="l" pos="9191520"/>
                <a:tab algn="l" pos="9804240"/>
                <a:tab algn="l" pos="10417320"/>
              </a:tabLst>
            </a:pP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1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Kaiser Permanente Colorado; 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2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Kaiser Permanente Care Management Institute; 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3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Health Media, Inc.; 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4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Group Health Cooperative; 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5</a:t>
            </a:r>
            <a:r>
              <a:rPr b="1" lang="en-US" sz="4000" spc="-1" strike="noStrike">
                <a:solidFill>
                  <a:srgbClr val="000000"/>
                </a:solidFill>
                <a:latin typeface="Garamond"/>
              </a:rPr>
              <a:t>University of Michigan</a:t>
            </a:r>
            <a:r>
              <a:rPr b="1" lang="en-US" sz="4000" spc="-1" strike="noStrike" baseline="30000">
                <a:solidFill>
                  <a:srgbClr val="000000"/>
                </a:solidFill>
                <a:latin typeface="Garamond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"/>
          <p:cNvSpPr/>
          <p:nvPr/>
        </p:nvSpPr>
        <p:spPr>
          <a:xfrm>
            <a:off x="30988080" y="3251160"/>
            <a:ext cx="431640" cy="108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15280" rIns="215280" tIns="107640" bIns="107640" anchor="t">
            <a:spAutoFit/>
          </a:bodyPr>
          <a:p>
            <a:pPr>
              <a:tabLst>
                <a:tab algn="l" pos="0"/>
                <a:tab algn="l" pos="2154240"/>
                <a:tab algn="l" pos="4308480"/>
                <a:tab algn="l" pos="6462720"/>
                <a:tab algn="l" pos="8616960"/>
                <a:tab algn="l" pos="107712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"/>
          <p:cNvSpPr/>
          <p:nvPr/>
        </p:nvSpPr>
        <p:spPr>
          <a:xfrm>
            <a:off x="38952360" y="10794960"/>
            <a:ext cx="432000" cy="108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15280" rIns="215280" tIns="107640" bIns="107640" anchor="t">
            <a:spAutoFit/>
          </a:bodyPr>
          <a:p>
            <a:pPr>
              <a:tabLst>
                <a:tab algn="l" pos="0"/>
                <a:tab algn="l" pos="2154240"/>
                <a:tab algn="l" pos="4308480"/>
                <a:tab algn="l" pos="6462720"/>
                <a:tab algn="l" pos="8616960"/>
                <a:tab algn="l" pos="107712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9" name=""/>
          <p:cNvGrpSpPr/>
          <p:nvPr/>
        </p:nvGrpSpPr>
        <p:grpSpPr>
          <a:xfrm>
            <a:off x="2109960" y="4514760"/>
            <a:ext cx="11370960" cy="4881960"/>
            <a:chOff x="2109960" y="4514760"/>
            <a:chExt cx="11370960" cy="4881960"/>
          </a:xfrm>
        </p:grpSpPr>
        <p:sp>
          <p:nvSpPr>
            <p:cNvPr id="40" name=""/>
            <p:cNvSpPr/>
            <p:nvPr/>
          </p:nvSpPr>
          <p:spPr>
            <a:xfrm>
              <a:off x="2165400" y="5435640"/>
              <a:ext cx="11260080" cy="3961080"/>
            </a:xfrm>
            <a:prstGeom prst="rect">
              <a:avLst/>
            </a:prstGeom>
            <a:solidFill>
              <a:srgbClr val="ffffff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61200" rIns="61200" tIns="30600" bIns="30600" anchor="t">
              <a:spAutoFit/>
            </a:bodyPr>
            <a:p>
              <a:pPr>
                <a:tabLst>
                  <a:tab algn="l" pos="0"/>
                  <a:tab algn="l" pos="612720"/>
                  <a:tab algn="l" pos="1225440"/>
                  <a:tab algn="l" pos="1838160"/>
                  <a:tab algn="l" pos="2451240"/>
                  <a:tab algn="l" pos="3063960"/>
                  <a:tab algn="l" pos="3676680"/>
                  <a:tab algn="l" pos="4289400"/>
                  <a:tab algn="l" pos="4902120"/>
                  <a:tab algn="l" pos="5514840"/>
                  <a:tab algn="l" pos="6127920"/>
                  <a:tab algn="l" pos="6740640"/>
                  <a:tab algn="l" pos="7353360"/>
                  <a:tab algn="l" pos="7966080"/>
                  <a:tab algn="l" pos="8578800"/>
                  <a:tab algn="l" pos="9191520"/>
                  <a:tab algn="l" pos="9804240"/>
                  <a:tab algn="l" pos="10417320"/>
                </a:tabLst>
              </a:pP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To study three process and implementation issues related to public health impact of Internet programs:</a:t>
              </a:r>
              <a:endParaRPr b="0" lang="en-US" sz="3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612720"/>
                  <a:tab algn="l" pos="1225440"/>
                  <a:tab algn="l" pos="1838160"/>
                  <a:tab algn="l" pos="2451240"/>
                  <a:tab algn="l" pos="3063960"/>
                  <a:tab algn="l" pos="3676680"/>
                  <a:tab algn="l" pos="4289400"/>
                  <a:tab algn="l" pos="4902120"/>
                  <a:tab algn="l" pos="5514840"/>
                  <a:tab algn="l" pos="6127920"/>
                  <a:tab algn="l" pos="6740640"/>
                  <a:tab algn="l" pos="7353360"/>
                  <a:tab algn="l" pos="7966080"/>
                  <a:tab algn="l" pos="8578800"/>
                  <a:tab algn="l" pos="9191520"/>
                  <a:tab algn="l" pos="9804240"/>
                  <a:tab algn="l" pos="10417320"/>
                </a:tabLst>
              </a:pP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    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1.  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What patient characteristics and recruitment methods 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produce higher </a:t>
              </a:r>
              <a:r>
                <a:rPr b="1" lang="en-US" sz="3200" spc="-1" strike="noStrike" u="sng">
                  <a:solidFill>
                    <a:srgbClr val="000000"/>
                  </a:solidFill>
                  <a:uFillTx/>
                  <a:latin typeface="Times New Roman"/>
                </a:rPr>
                <a:t>enrollment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?</a:t>
              </a:r>
              <a:endParaRPr b="0" lang="en-US" sz="3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612720"/>
                  <a:tab algn="l" pos="1225440"/>
                  <a:tab algn="l" pos="1838160"/>
                  <a:tab algn="l" pos="2451240"/>
                  <a:tab algn="l" pos="3063960"/>
                  <a:tab algn="l" pos="3676680"/>
                  <a:tab algn="l" pos="4289400"/>
                  <a:tab algn="l" pos="4902120"/>
                  <a:tab algn="l" pos="5514840"/>
                  <a:tab algn="l" pos="6127920"/>
                  <a:tab algn="l" pos="6740640"/>
                  <a:tab algn="l" pos="7353360"/>
                  <a:tab algn="l" pos="7966080"/>
                  <a:tab algn="l" pos="8578800"/>
                  <a:tab algn="l" pos="9191520"/>
                  <a:tab algn="l" pos="9804240"/>
                  <a:tab algn="l" pos="10417320"/>
                </a:tabLst>
              </a:pP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    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2.  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What patient characteristics are related to level of user 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 u="sng">
                  <a:solidFill>
                    <a:srgbClr val="000000"/>
                  </a:solidFill>
                  <a:uFillTx/>
                  <a:latin typeface="Times New Roman"/>
                </a:rPr>
                <a:t>engagement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?</a:t>
              </a:r>
              <a:endParaRPr b="0" lang="en-US" sz="3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612720"/>
                  <a:tab algn="l" pos="1225440"/>
                  <a:tab algn="l" pos="1838160"/>
                  <a:tab algn="l" pos="2451240"/>
                  <a:tab algn="l" pos="3063960"/>
                  <a:tab algn="l" pos="3676680"/>
                  <a:tab algn="l" pos="4289400"/>
                  <a:tab algn="l" pos="4902120"/>
                  <a:tab algn="l" pos="5514840"/>
                  <a:tab algn="l" pos="6127920"/>
                  <a:tab algn="l" pos="6740640"/>
                  <a:tab algn="l" pos="7353360"/>
                  <a:tab algn="l" pos="7966080"/>
                  <a:tab algn="l" pos="8578800"/>
                  <a:tab algn="l" pos="9191520"/>
                  <a:tab algn="l" pos="9804240"/>
                  <a:tab algn="l" pos="10417320"/>
                </a:tabLst>
              </a:pP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    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3.  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What patient characteristics are related to retention in 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1" lang="en-US" sz="3200" spc="-1" strike="noStrike" u="sng">
                  <a:solidFill>
                    <a:srgbClr val="000000"/>
                  </a:solidFill>
                  <a:uFillTx/>
                  <a:latin typeface="Times New Roman"/>
                </a:rPr>
                <a:t>follow-up assessment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?</a:t>
              </a:r>
              <a:r>
                <a:rPr b="1" lang="en-US" sz="32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endParaRPr b="0" lang="en-US" sz="3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" name=""/>
            <p:cNvSpPr/>
            <p:nvPr/>
          </p:nvSpPr>
          <p:spPr>
            <a:xfrm>
              <a:off x="2109960" y="4514760"/>
              <a:ext cx="11370960" cy="642600"/>
            </a:xfrm>
            <a:prstGeom prst="rect">
              <a:avLst/>
            </a:prstGeom>
            <a:solidFill>
              <a:srgbClr val="ffff99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PURPOSE AND QUESTIONS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42" name=""/>
          <p:cNvGrpSpPr/>
          <p:nvPr/>
        </p:nvGrpSpPr>
        <p:grpSpPr>
          <a:xfrm>
            <a:off x="2165400" y="11126880"/>
            <a:ext cx="11260080" cy="2938320"/>
            <a:chOff x="2165400" y="11126880"/>
            <a:chExt cx="11260080" cy="2938320"/>
          </a:xfrm>
        </p:grpSpPr>
        <p:sp>
          <p:nvSpPr>
            <p:cNvPr id="43" name=""/>
            <p:cNvSpPr/>
            <p:nvPr/>
          </p:nvSpPr>
          <p:spPr>
            <a:xfrm>
              <a:off x="2165400" y="12053880"/>
              <a:ext cx="11260080" cy="2011320"/>
            </a:xfrm>
            <a:prstGeom prst="rect">
              <a:avLst/>
            </a:prstGeom>
            <a:solidFill>
              <a:srgbClr val="ffffff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61200" rIns="61200" tIns="30600" bIns="306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12720"/>
                  <a:tab algn="l" pos="1225440"/>
                  <a:tab algn="l" pos="1838160"/>
                  <a:tab algn="l" pos="2451240"/>
                  <a:tab algn="l" pos="3063960"/>
                  <a:tab algn="l" pos="3676680"/>
                  <a:tab algn="l" pos="4289400"/>
                  <a:tab algn="l" pos="4902120"/>
                  <a:tab algn="l" pos="5514840"/>
                  <a:tab algn="l" pos="6127920"/>
                  <a:tab algn="l" pos="6740640"/>
                  <a:tab algn="l" pos="7353360"/>
                  <a:tab algn="l" pos="7966080"/>
                  <a:tab algn="l" pos="8578800"/>
                  <a:tab algn="l" pos="9191520"/>
                  <a:tab algn="l" pos="9804240"/>
                  <a:tab algn="l" pos="10417320"/>
                </a:tabLst>
              </a:pPr>
              <a:r>
                <a:rPr b="1" lang="en-US" sz="3200" spc="-1" strike="noStrike" u="sng">
                  <a:solidFill>
                    <a:srgbClr val="000000"/>
                  </a:solidFill>
                  <a:uFillTx/>
                  <a:latin typeface="Garamond"/>
                </a:rPr>
                <a:t>Setting and Target Populations</a:t>
              </a:r>
              <a:endParaRPr b="0" lang="en-US" sz="3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612720"/>
                  <a:tab algn="l" pos="1225440"/>
                  <a:tab algn="l" pos="1838160"/>
                  <a:tab algn="l" pos="2451240"/>
                  <a:tab algn="l" pos="3063960"/>
                  <a:tab algn="l" pos="3676680"/>
                  <a:tab algn="l" pos="4289400"/>
                  <a:tab algn="l" pos="4902120"/>
                  <a:tab algn="l" pos="5514840"/>
                  <a:tab algn="l" pos="6127920"/>
                  <a:tab algn="l" pos="6740640"/>
                  <a:tab algn="l" pos="7353360"/>
                  <a:tab algn="l" pos="7966080"/>
                  <a:tab algn="l" pos="8578800"/>
                  <a:tab algn="l" pos="9191520"/>
                  <a:tab algn="l" pos="9804240"/>
                  <a:tab algn="l" pos="10417320"/>
                </a:tabLst>
              </a:pP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Members of three large healthcare plans in different parts of the U.S. who had BMI &gt; 30 (25 if also had chronic illness).</a:t>
              </a:r>
              <a:endParaRPr b="0" lang="en-US" sz="3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187720" y="11126880"/>
              <a:ext cx="11218680" cy="642600"/>
            </a:xfrm>
            <a:prstGeom prst="rect">
              <a:avLst/>
            </a:prstGeom>
            <a:solidFill>
              <a:srgbClr val="ffff99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METHODS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45" name=""/>
          <p:cNvGrpSpPr/>
          <p:nvPr/>
        </p:nvGrpSpPr>
        <p:grpSpPr>
          <a:xfrm>
            <a:off x="19575360" y="4514760"/>
            <a:ext cx="11891880" cy="9891360"/>
            <a:chOff x="19575360" y="4514760"/>
            <a:chExt cx="11891880" cy="9891360"/>
          </a:xfrm>
        </p:grpSpPr>
        <p:sp>
          <p:nvSpPr>
            <p:cNvPr id="46" name=""/>
            <p:cNvSpPr/>
            <p:nvPr/>
          </p:nvSpPr>
          <p:spPr>
            <a:xfrm>
              <a:off x="19575360" y="5533920"/>
              <a:ext cx="11891880" cy="8872200"/>
            </a:xfrm>
            <a:prstGeom prst="rect">
              <a:avLst/>
            </a:prstGeom>
            <a:solidFill>
              <a:srgbClr val="ffffff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I.  </a:t>
              </a:r>
              <a:r>
                <a:rPr b="1" lang="en-US" sz="2400" spc="-1" strike="noStrike" u="sng">
                  <a:solidFill>
                    <a:srgbClr val="000000"/>
                  </a:solidFill>
                  <a:uFillTx/>
                  <a:latin typeface="Garamond"/>
                </a:rPr>
                <a:t>Enrollment Rates:  total enrollment n = 2311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    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Among those sent personal letters (HMO 1):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-  Having diabetes (6.6%)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-  Having hyperlipidemia (10.0%)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-  No identified illness (2.4%)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    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Among general HMO population recruited via health plan newsletter notices (1.7%)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II.  </a:t>
              </a:r>
              <a:r>
                <a:rPr b="1" lang="en-US" sz="2400" spc="-1" strike="noStrike" u="sng">
                  <a:solidFill>
                    <a:srgbClr val="000000"/>
                  </a:solidFill>
                  <a:uFillTx/>
                  <a:latin typeface="Garamond"/>
                </a:rPr>
                <a:t>Characteristics of Enrollees and Decliners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 u="sng">
                  <a:solidFill>
                    <a:srgbClr val="000000"/>
                  </a:solidFill>
                  <a:uFillTx/>
                  <a:latin typeface="Garamond"/>
                </a:rPr>
                <a:t>Enrollees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 u="sng">
                  <a:solidFill>
                    <a:srgbClr val="000000"/>
                  </a:solidFill>
                  <a:uFillTx/>
                  <a:latin typeface="Garamond"/>
                </a:rPr>
                <a:t>Decliners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 u="sng">
                  <a:solidFill>
                    <a:srgbClr val="000000"/>
                  </a:solidFill>
                  <a:uFillTx/>
                  <a:latin typeface="Garamond"/>
                </a:rPr>
                <a:t>Sig. Level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Age</a:t>
              </a:r>
              <a:r>
                <a:rPr b="0" lang="en-US" sz="2400" spc="-1" strike="noStrike">
                  <a:solidFill>
                    <a:srgbClr val="000000"/>
                  </a:solidFill>
                  <a:latin typeface="Garamond"/>
                </a:rPr>
                <a:t> 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i="1" lang="en-US" sz="2400" spc="-1" strike="noStrike">
                  <a:solidFill>
                    <a:srgbClr val="000000"/>
                  </a:solidFill>
                  <a:latin typeface="Garamond"/>
                </a:rPr>
                <a:t>p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&lt;.001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 u="sng">
                  <a:solidFill>
                    <a:srgbClr val="000000"/>
                  </a:solidFill>
                  <a:uFillTx/>
                  <a:latin typeface="Garamond"/>
                </a:rPr>
                <a:t>&gt;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60 years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46.5%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60.0%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Gender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i="1" lang="en-US" sz="2400" spc="-1" strike="noStrike">
                  <a:solidFill>
                    <a:srgbClr val="000000"/>
                  </a:solidFill>
                  <a:latin typeface="Garamond"/>
                </a:rPr>
                <a:t>p</a:t>
              </a:r>
              <a:r>
                <a:rPr b="0" lang="en-US" sz="2400" spc="-1" strike="noStrike">
                  <a:solidFill>
                    <a:srgbClr val="000000"/>
                  </a:solidFill>
                  <a:latin typeface="Garamond"/>
                </a:rPr>
                <a:t> &lt;.001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 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Male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46.7%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58.1%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Smoking Status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i="1" lang="en-US" sz="2400" spc="-1" strike="noStrike">
                  <a:solidFill>
                    <a:srgbClr val="000000"/>
                  </a:solidFill>
                  <a:latin typeface="Garamond"/>
                </a:rPr>
                <a:t>p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&lt;.001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Current Smoker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5.7%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12.2%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RxRisk (Estimated Medical Costs)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</a:t>
              </a:r>
              <a:r>
                <a:rPr b="1" i="1" lang="en-US" sz="2400" spc="-1" strike="noStrike">
                  <a:solidFill>
                    <a:srgbClr val="000000"/>
                  </a:solidFill>
                  <a:latin typeface="Garamond"/>
                </a:rPr>
                <a:t>p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&lt;.001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 u="sng">
                  <a:solidFill>
                    <a:srgbClr val="000000"/>
                  </a:solidFill>
                  <a:uFillTx/>
                  <a:latin typeface="Garamond"/>
                </a:rPr>
                <a:t>&gt;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 $3000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44.4%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2400" spc="-1" strike="noStrike">
                  <a:solidFill>
                    <a:srgbClr val="000000"/>
                  </a:solidFill>
                  <a:latin typeface="Garamond"/>
                </a:rPr>
                <a:t>55.7%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857160"/>
                  <a:tab algn="l" pos="1371600"/>
                  <a:tab algn="l" pos="177156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9581840" y="4514760"/>
              <a:ext cx="11876040" cy="642600"/>
            </a:xfrm>
            <a:prstGeom prst="rect">
              <a:avLst/>
            </a:prstGeom>
            <a:solidFill>
              <a:srgbClr val="ffff99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RECRUITMENT AND REACH (ENROLLMENT)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aphicFrame>
        <p:nvGraphicFramePr>
          <p:cNvPr id="48" name=""/>
          <p:cNvGraphicFramePr/>
          <p:nvPr/>
        </p:nvGraphicFramePr>
        <p:xfrm>
          <a:off x="1390680" y="488880"/>
          <a:ext cx="5668920" cy="809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90680" y="488880"/>
                    <a:ext cx="5668920" cy="80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"/>
          <p:cNvGraphicFramePr/>
          <p:nvPr/>
        </p:nvGraphicFramePr>
        <p:xfrm>
          <a:off x="43841880" y="476280"/>
          <a:ext cx="6105600" cy="9874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1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3841880" y="476280"/>
                    <a:ext cx="6105600" cy="987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52" name=""/>
          <p:cNvGrpSpPr/>
          <p:nvPr/>
        </p:nvGrpSpPr>
        <p:grpSpPr>
          <a:xfrm>
            <a:off x="2165400" y="15309720"/>
            <a:ext cx="11260080" cy="5874480"/>
            <a:chOff x="2165400" y="15309720"/>
            <a:chExt cx="11260080" cy="5874480"/>
          </a:xfrm>
        </p:grpSpPr>
        <p:sp>
          <p:nvSpPr>
            <p:cNvPr id="53" name=""/>
            <p:cNvSpPr/>
            <p:nvPr/>
          </p:nvSpPr>
          <p:spPr>
            <a:xfrm>
              <a:off x="2165400" y="16248240"/>
              <a:ext cx="11260080" cy="4935960"/>
            </a:xfrm>
            <a:prstGeom prst="rect">
              <a:avLst/>
            </a:prstGeom>
            <a:solidFill>
              <a:srgbClr val="ffffff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61200" rIns="61200" tIns="30600" bIns="306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14440"/>
                  <a:tab algn="l" pos="914400"/>
                  <a:tab algn="l" pos="1225440"/>
                  <a:tab algn="l" pos="1838160"/>
                  <a:tab algn="l" pos="2451240"/>
                  <a:tab algn="l" pos="3063960"/>
                  <a:tab algn="l" pos="3676680"/>
                  <a:tab algn="l" pos="4289400"/>
                  <a:tab algn="l" pos="4902120"/>
                  <a:tab algn="l" pos="5514840"/>
                  <a:tab algn="l" pos="6127920"/>
                  <a:tab algn="l" pos="6740640"/>
                  <a:tab algn="l" pos="7353360"/>
                  <a:tab algn="l" pos="7966080"/>
                  <a:tab algn="l" pos="8578800"/>
                  <a:tab algn="l" pos="9191520"/>
                  <a:tab algn="l" pos="9804240"/>
                  <a:tab algn="l" pos="10417320"/>
                </a:tabLst>
              </a:pP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All participants received an Internet weight loss program validated in prior study (Rothert, et al).  Participants then randomized within 2x2 factorial RCT to:</a:t>
              </a:r>
              <a:endParaRPr b="0" lang="en-US" sz="3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514440"/>
                  <a:tab algn="l" pos="914400"/>
                  <a:tab algn="l" pos="1225440"/>
                  <a:tab algn="l" pos="1838160"/>
                  <a:tab algn="l" pos="2451240"/>
                  <a:tab algn="l" pos="3063960"/>
                  <a:tab algn="l" pos="3676680"/>
                  <a:tab algn="l" pos="4289400"/>
                  <a:tab algn="l" pos="4902120"/>
                  <a:tab algn="l" pos="5514840"/>
                  <a:tab algn="l" pos="6127920"/>
                  <a:tab algn="l" pos="6740640"/>
                  <a:tab algn="l" pos="7353360"/>
                  <a:tab algn="l" pos="7966080"/>
                  <a:tab algn="l" pos="8578800"/>
                  <a:tab algn="l" pos="9191520"/>
                  <a:tab algn="l" pos="9804240"/>
                  <a:tab algn="l" pos="10417320"/>
                </a:tabLst>
              </a:pP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-  Receive </a:t>
              </a:r>
              <a:r>
                <a:rPr b="1" i="1" lang="en-US" sz="3200" spc="-1" strike="noStrike">
                  <a:solidFill>
                    <a:srgbClr val="000000"/>
                  </a:solidFill>
                  <a:latin typeface="Garamond"/>
                </a:rPr>
                <a:t>Achieve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 goal setting program or not (introduced 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concurrently with basic program)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endParaRPr b="0" lang="en-US" sz="3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514440"/>
                  <a:tab algn="l" pos="914400"/>
                  <a:tab algn="l" pos="1225440"/>
                  <a:tab algn="l" pos="1838160"/>
                  <a:tab algn="l" pos="2451240"/>
                  <a:tab algn="l" pos="3063960"/>
                  <a:tab algn="l" pos="3676680"/>
                  <a:tab algn="l" pos="4289400"/>
                  <a:tab algn="l" pos="4902120"/>
                  <a:tab algn="l" pos="5514840"/>
                  <a:tab algn="l" pos="6127920"/>
                  <a:tab algn="l" pos="6740640"/>
                  <a:tab algn="l" pos="7353360"/>
                  <a:tab algn="l" pos="7966080"/>
                  <a:tab algn="l" pos="8578800"/>
                  <a:tab algn="l" pos="9191520"/>
                  <a:tab algn="l" pos="9804240"/>
                  <a:tab algn="l" pos="10417320"/>
                </a:tabLst>
              </a:pP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-  Receive </a:t>
              </a:r>
              <a:r>
                <a:rPr b="1" i="1" lang="en-US" sz="3200" spc="-1" strike="noStrike">
                  <a:solidFill>
                    <a:srgbClr val="000000"/>
                  </a:solidFill>
                  <a:latin typeface="Garamond"/>
                </a:rPr>
                <a:t>Nourish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 nutritional education program or not 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r>
                <a:rPr b="1" lang="en-US" sz="3200" spc="-1" strike="noStrike">
                  <a:solidFill>
                    <a:srgbClr val="000000"/>
                  </a:solidFill>
                  <a:latin typeface="Garamond"/>
                </a:rPr>
                <a:t>(introduced at three months after basic program)</a:t>
              </a:r>
              <a:endParaRPr b="0" lang="en-US" sz="3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185920" y="15309720"/>
              <a:ext cx="11218320" cy="642600"/>
            </a:xfrm>
            <a:prstGeom prst="rect">
              <a:avLst/>
            </a:prstGeom>
            <a:solidFill>
              <a:srgbClr val="ffff99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INTERVENTIONS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aphicFrame>
        <p:nvGraphicFramePr>
          <p:cNvPr id="55" name=""/>
          <p:cNvGraphicFramePr/>
          <p:nvPr/>
        </p:nvGraphicFramePr>
        <p:xfrm>
          <a:off x="5794200" y="20575440"/>
          <a:ext cx="4000680" cy="60120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794200" y="20575440"/>
                    <a:ext cx="4000680" cy="6012000"/>
                  </a:xfrm>
                  <a:prstGeom prst="rect">
                    <a:avLst/>
                  </a:prstGeom>
                  <a:ln w="38160">
                    <a:solidFill>
                      <a:srgbClr val="ffff00"/>
                    </a:solidFill>
                    <a:miter/>
                  </a:ln>
                </p:spPr>
              </p:pic>
            </p:oleObj>
          </a:graphicData>
        </a:graphic>
      </p:graphicFrame>
      <p:grpSp>
        <p:nvGrpSpPr>
          <p:cNvPr id="57" name=""/>
          <p:cNvGrpSpPr/>
          <p:nvPr/>
        </p:nvGrpSpPr>
        <p:grpSpPr>
          <a:xfrm>
            <a:off x="32942160" y="19519920"/>
            <a:ext cx="17948880" cy="6505920"/>
            <a:chOff x="32942160" y="19519920"/>
            <a:chExt cx="17948880" cy="6505920"/>
          </a:xfrm>
        </p:grpSpPr>
        <p:sp>
          <p:nvSpPr>
            <p:cNvPr id="58" name=""/>
            <p:cNvSpPr/>
            <p:nvPr/>
          </p:nvSpPr>
          <p:spPr>
            <a:xfrm>
              <a:off x="34463160" y="19519920"/>
              <a:ext cx="14906520" cy="642600"/>
            </a:xfrm>
            <a:prstGeom prst="rect">
              <a:avLst/>
            </a:prstGeom>
            <a:solidFill>
              <a:srgbClr val="ffff99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CONCLUSIONS AND IMPLICATIONS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2942160" y="20445480"/>
              <a:ext cx="17948880" cy="5580360"/>
            </a:xfrm>
            <a:prstGeom prst="rect">
              <a:avLst/>
            </a:prstGeom>
            <a:solidFill>
              <a:srgbClr val="ffffff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marL="457200" indent="-457200">
                <a:lnSpc>
                  <a:spcPct val="100000"/>
                </a:lnSpc>
                <a:buClr>
                  <a:srgbClr val="000000"/>
                </a:buClr>
                <a:buFont typeface="Garamond"/>
                <a:buAutoNum type="arabicPeriod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 u="sng">
                  <a:solidFill>
                    <a:srgbClr val="000000"/>
                  </a:solidFill>
                  <a:uFillTx/>
                  <a:latin typeface="Garamond"/>
                </a:rPr>
                <a:t>Enrollment</a:t>
              </a: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:  Personal letters enhance reach; although Web programs may</a:t>
              </a:r>
              <a:br>
                <a:rPr sz="3600"/>
              </a:b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not reach highest risk, those with diabetes or heart disease are more likely</a:t>
              </a:r>
              <a:br>
                <a:rPr sz="3600"/>
              </a:b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to enroll.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7200">
                <a:lnSpc>
                  <a:spcPct val="100000"/>
                </a:lnSpc>
                <a:buClr>
                  <a:srgbClr val="000000"/>
                </a:buClr>
                <a:buFont typeface="Garamond"/>
                <a:buAutoNum type="arabicPeriod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 u="sng">
                  <a:solidFill>
                    <a:srgbClr val="000000"/>
                  </a:solidFill>
                  <a:uFillTx/>
                  <a:latin typeface="Garamond"/>
                </a:rPr>
                <a:t>Engagement</a:t>
              </a: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:  It is challenging to keep Web-users engaged over time,</a:t>
              </a:r>
              <a:br>
                <a:rPr sz="3600"/>
              </a:b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especially males.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7200">
                <a:lnSpc>
                  <a:spcPct val="100000"/>
                </a:lnSpc>
                <a:buClr>
                  <a:srgbClr val="000000"/>
                </a:buClr>
                <a:buFont typeface="Garamond"/>
                <a:buAutoNum type="arabicPeriod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 u="sng">
                  <a:solidFill>
                    <a:srgbClr val="000000"/>
                  </a:solidFill>
                  <a:uFillTx/>
                  <a:latin typeface="Garamond"/>
                </a:rPr>
                <a:t>Retention for Assessment</a:t>
              </a: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:  Even more challenging at long-term</a:t>
              </a:r>
              <a:br>
                <a:rPr sz="3600"/>
              </a:b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follow-up, especially for younger participants and those more </a:t>
              </a:r>
              <a:br>
                <a:rPr sz="3600"/>
              </a:b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confident at baseline.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7200">
                <a:lnSpc>
                  <a:spcPct val="100000"/>
                </a:lnSpc>
                <a:buClr>
                  <a:srgbClr val="000000"/>
                </a:buClr>
                <a:buFont typeface="Garamond"/>
                <a:buAutoNum type="arabicPeriod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 u="sng">
                  <a:solidFill>
                    <a:srgbClr val="000000"/>
                  </a:solidFill>
                  <a:uFillTx/>
                  <a:latin typeface="Garamond"/>
                </a:rPr>
                <a:t>Overall</a:t>
              </a: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:  Factors influencing these three processes or stages appear</a:t>
              </a:r>
              <a:br>
                <a:rPr sz="3600"/>
              </a:b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to be different.  Greater attention is needed to all three.</a:t>
              </a: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	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60" name=""/>
          <p:cNvGrpSpPr/>
          <p:nvPr/>
        </p:nvGrpSpPr>
        <p:grpSpPr>
          <a:xfrm>
            <a:off x="35893440" y="4514760"/>
            <a:ext cx="12079080" cy="8469360"/>
            <a:chOff x="35893440" y="4514760"/>
            <a:chExt cx="12079080" cy="8469360"/>
          </a:xfrm>
        </p:grpSpPr>
        <p:sp>
          <p:nvSpPr>
            <p:cNvPr id="61" name=""/>
            <p:cNvSpPr/>
            <p:nvPr/>
          </p:nvSpPr>
          <p:spPr>
            <a:xfrm>
              <a:off x="35926560" y="4514760"/>
              <a:ext cx="12009600" cy="642600"/>
            </a:xfrm>
            <a:prstGeom prst="rect">
              <a:avLst/>
            </a:prstGeom>
            <a:solidFill>
              <a:srgbClr val="ffff99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RETENTION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5893440" y="5448240"/>
              <a:ext cx="12079080" cy="7535880"/>
            </a:xfrm>
            <a:prstGeom prst="rect">
              <a:avLst/>
            </a:prstGeom>
            <a:solidFill>
              <a:srgbClr val="ffffff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aphicFrame>
          <p:nvGraphicFramePr>
            <p:cNvPr id="63" name=""/>
            <p:cNvGraphicFramePr/>
            <p:nvPr/>
          </p:nvGraphicFramePr>
          <p:xfrm>
            <a:off x="36241200" y="6043680"/>
            <a:ext cx="11382120" cy="6345000"/>
          </p:xfrm>
          <a:graphic>
            <a:graphicData uri="http://schemas.openxmlformats.org/presentationml/2006/ole">
              <p:oleObj progId="Word.Document.12" r:id="rId7" spid="">
                <p:embed/>
                <p:pic>
                  <p:nvPicPr>
                    <p:cNvPr id="64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36241200" y="6043680"/>
                      <a:ext cx="11382120" cy="6345000"/>
                    </a:xfrm>
                    <a:prstGeom prst="rect">
                      <a:avLst/>
                    </a:prstGeom>
                    <a:ln w="5724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</p:grpSp>
      <p:graphicFrame>
        <p:nvGraphicFramePr>
          <p:cNvPr id="65" name=""/>
          <p:cNvGraphicFramePr/>
          <p:nvPr/>
        </p:nvGraphicFramePr>
        <p:xfrm>
          <a:off x="2259000" y="1762200"/>
          <a:ext cx="3933720" cy="180972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66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2259000" y="1762200"/>
                    <a:ext cx="3933720" cy="1809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67" name=""/>
          <p:cNvGrpSpPr/>
          <p:nvPr/>
        </p:nvGrpSpPr>
        <p:grpSpPr>
          <a:xfrm>
            <a:off x="43205400" y="2355840"/>
            <a:ext cx="7277040" cy="1143000"/>
            <a:chOff x="43205400" y="2355840"/>
            <a:chExt cx="7277040" cy="1143000"/>
          </a:xfrm>
        </p:grpSpPr>
        <p:sp>
          <p:nvSpPr>
            <p:cNvPr id="68" name=""/>
            <p:cNvSpPr/>
            <p:nvPr/>
          </p:nvSpPr>
          <p:spPr>
            <a:xfrm>
              <a:off x="43205400" y="2355840"/>
              <a:ext cx="7277040" cy="1143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aphicFrame>
          <p:nvGraphicFramePr>
            <p:cNvPr id="69" name=""/>
            <p:cNvGraphicFramePr/>
            <p:nvPr/>
          </p:nvGraphicFramePr>
          <p:xfrm>
            <a:off x="43449840" y="2527200"/>
            <a:ext cx="6788160" cy="79992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70" name="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43449840" y="2527200"/>
                      <a:ext cx="6788160" cy="799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grpSp>
        <p:nvGrpSpPr>
          <p:cNvPr id="71" name=""/>
          <p:cNvGrpSpPr/>
          <p:nvPr/>
        </p:nvGrpSpPr>
        <p:grpSpPr>
          <a:xfrm>
            <a:off x="34118640" y="13716000"/>
            <a:ext cx="15544800" cy="4543560"/>
            <a:chOff x="34118640" y="13716000"/>
            <a:chExt cx="15544800" cy="4543560"/>
          </a:xfrm>
        </p:grpSpPr>
        <p:graphicFrame>
          <p:nvGraphicFramePr>
            <p:cNvPr id="72" name=""/>
            <p:cNvGraphicFramePr/>
            <p:nvPr/>
          </p:nvGraphicFramePr>
          <p:xfrm>
            <a:off x="39455640" y="13716000"/>
            <a:ext cx="4932360" cy="328140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73" name="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39455640" y="13716000"/>
                      <a:ext cx="4932360" cy="3281400"/>
                    </a:xfrm>
                    <a:prstGeom prst="rect">
                      <a:avLst/>
                    </a:prstGeom>
                    <a:ln w="38160">
                      <a:solidFill>
                        <a:srgbClr val="ffff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74" name=""/>
            <p:cNvGraphicFramePr/>
            <p:nvPr/>
          </p:nvGraphicFramePr>
          <p:xfrm>
            <a:off x="34118640" y="15516360"/>
            <a:ext cx="4114800" cy="274320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75" name="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34118640" y="15516360"/>
                      <a:ext cx="4114800" cy="2743200"/>
                    </a:xfrm>
                    <a:prstGeom prst="rect">
                      <a:avLst/>
                    </a:prstGeom>
                    <a:ln w="38160">
                      <a:solidFill>
                        <a:srgbClr val="ffff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76" name=""/>
            <p:cNvGraphicFramePr/>
            <p:nvPr/>
          </p:nvGraphicFramePr>
          <p:xfrm>
            <a:off x="45548640" y="15516360"/>
            <a:ext cx="4114800" cy="2743200"/>
          </p:xfrm>
          <a:graphic>
            <a:graphicData uri="http://schemas.openxmlformats.org/presentationml/2006/ole">
              <p:oleObj r:id="rId17" spid="">
                <p:embed/>
                <p:pic>
                  <p:nvPicPr>
                    <p:cNvPr id="77" name="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45548640" y="15516360"/>
                      <a:ext cx="4114800" cy="2743200"/>
                    </a:xfrm>
                    <a:prstGeom prst="rect">
                      <a:avLst/>
                    </a:prstGeom>
                    <a:ln w="38160">
                      <a:solidFill>
                        <a:srgbClr val="ffff00"/>
                      </a:solidFill>
                      <a:miter/>
                    </a:ln>
                  </p:spPr>
                </p:pic>
              </p:oleObj>
            </a:graphicData>
          </a:graphic>
        </p:graphicFrame>
      </p:grpSp>
      <p:grpSp>
        <p:nvGrpSpPr>
          <p:cNvPr id="78" name=""/>
          <p:cNvGrpSpPr/>
          <p:nvPr/>
        </p:nvGrpSpPr>
        <p:grpSpPr>
          <a:xfrm>
            <a:off x="19553400" y="14444640"/>
            <a:ext cx="11945880" cy="12442680"/>
            <a:chOff x="19553400" y="14444640"/>
            <a:chExt cx="11945880" cy="12442680"/>
          </a:xfrm>
        </p:grpSpPr>
        <p:sp>
          <p:nvSpPr>
            <p:cNvPr id="79" name=""/>
            <p:cNvSpPr/>
            <p:nvPr/>
          </p:nvSpPr>
          <p:spPr>
            <a:xfrm>
              <a:off x="19553400" y="14444640"/>
              <a:ext cx="11908080" cy="642600"/>
            </a:xfrm>
            <a:prstGeom prst="rect">
              <a:avLst/>
            </a:prstGeom>
            <a:solidFill>
              <a:srgbClr val="ffff99"/>
            </a:solidFill>
            <a:ln w="57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600" spc="-1" strike="noStrike">
                  <a:solidFill>
                    <a:srgbClr val="000000"/>
                  </a:solidFill>
                  <a:latin typeface="Garamond"/>
                </a:rPr>
                <a:t>ENGAGEMENT</a:t>
              </a:r>
              <a:endParaRPr b="0" lang="en-US" sz="3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80" name=""/>
            <p:cNvGrpSpPr/>
            <p:nvPr/>
          </p:nvGrpSpPr>
          <p:grpSpPr>
            <a:xfrm>
              <a:off x="19555200" y="15400440"/>
              <a:ext cx="11944080" cy="11486880"/>
              <a:chOff x="19555200" y="15400440"/>
              <a:chExt cx="11944080" cy="11486880"/>
            </a:xfrm>
          </p:grpSpPr>
          <p:sp>
            <p:nvSpPr>
              <p:cNvPr id="81" name=""/>
              <p:cNvSpPr/>
              <p:nvPr/>
            </p:nvSpPr>
            <p:spPr>
              <a:xfrm>
                <a:off x="19555200" y="15400440"/>
                <a:ext cx="11944080" cy="11486880"/>
              </a:xfrm>
              <a:prstGeom prst="rect">
                <a:avLst/>
              </a:prstGeom>
              <a:solidFill>
                <a:srgbClr val="ffffff"/>
              </a:solidFill>
              <a:ln w="57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aphicFrame>
            <p:nvGraphicFramePr>
              <p:cNvPr id="82" name=""/>
              <p:cNvGraphicFramePr/>
              <p:nvPr/>
            </p:nvGraphicFramePr>
            <p:xfrm>
              <a:off x="20444040" y="21948840"/>
              <a:ext cx="10164960" cy="4422600"/>
            </p:xfrm>
            <a:graphic>
              <a:graphicData uri="http://schemas.openxmlformats.org/presentationml/2006/ole">
                <p:oleObj progId="Word.Document.12" r:id="rId19" spid="">
                  <p:embed/>
                  <p:pic>
                    <p:nvPicPr>
                      <p:cNvPr id="83" name="" descr=""/>
                      <p:cNvPicPr/>
                      <p:nvPr/>
                    </p:nvPicPr>
                    <p:blipFill>
                      <a:blip r:embed="rId20"/>
                      <a:stretch/>
                    </p:blipFill>
                    <p:spPr>
                      <a:xfrm>
                        <a:off x="20444040" y="21948840"/>
                        <a:ext cx="10164960" cy="4422600"/>
                      </a:xfrm>
                      <a:prstGeom prst="rect">
                        <a:avLst/>
                      </a:prstGeom>
                      <a:ln w="5724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</p:grpSp>
        <p:grpSp>
          <p:nvGrpSpPr>
            <p:cNvPr id="84" name=""/>
            <p:cNvGrpSpPr/>
            <p:nvPr/>
          </p:nvGrpSpPr>
          <p:grpSpPr>
            <a:xfrm>
              <a:off x="20466720" y="15592320"/>
              <a:ext cx="9990360" cy="5520600"/>
              <a:chOff x="20466720" y="15592320"/>
              <a:chExt cx="9990360" cy="5520600"/>
            </a:xfrm>
          </p:grpSpPr>
          <p:sp>
            <p:nvSpPr>
              <p:cNvPr id="85" name=""/>
              <p:cNvSpPr/>
              <p:nvPr/>
            </p:nvSpPr>
            <p:spPr>
              <a:xfrm>
                <a:off x="21067920" y="15592320"/>
                <a:ext cx="61560" cy="289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9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endParaRPr b="0" lang="en-US" sz="1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20466720" y="16141320"/>
                <a:ext cx="650808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I.  Overall Rates of Program Engagement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6715960" y="1614132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3404680" y="1650816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2306680" y="16865280"/>
                <a:ext cx="21297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Condition (n)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4350040" y="1686528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6533440" y="16508160"/>
                <a:ext cx="107352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Initial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25984080" y="16865280"/>
                <a:ext cx="197892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Engagement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27892080" y="16849440"/>
                <a:ext cx="1072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500" spc="-1" strike="noStrike">
                    <a:solidFill>
                      <a:srgbClr val="000000"/>
                    </a:solidFill>
                    <a:latin typeface="Garamond"/>
                  </a:rPr>
                  <a:t>1</a:t>
                </a:r>
                <a:endParaRPr b="0" lang="en-US" sz="1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27982080" y="1686528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28462320" y="16508160"/>
                <a:ext cx="141660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Ongoing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28087560" y="16865280"/>
                <a:ext cx="197892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Engagement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30002040" y="16849440"/>
                <a:ext cx="1072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500" spc="-1" strike="noStrike">
                    <a:solidFill>
                      <a:srgbClr val="000000"/>
                    </a:solidFill>
                    <a:latin typeface="Garamond"/>
                  </a:rPr>
                  <a:t>2</a:t>
                </a:r>
                <a:endParaRPr b="0" lang="en-US" sz="1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30098880" y="1686528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0818800" y="16497000"/>
                <a:ext cx="5167080" cy="9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20818800" y="16497000"/>
                <a:ext cx="5167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5985880" y="16497000"/>
                <a:ext cx="9720" cy="9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25985880" y="16497000"/>
                <a:ext cx="9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25985880" y="16497000"/>
                <a:ext cx="1800" cy="9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25995600" y="16497000"/>
                <a:ext cx="2093760" cy="9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5995600" y="16497000"/>
                <a:ext cx="20937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28089360" y="16497000"/>
                <a:ext cx="9720" cy="9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28089360" y="16497000"/>
                <a:ext cx="9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28089360" y="16497000"/>
                <a:ext cx="1800" cy="9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28099080" y="16497000"/>
                <a:ext cx="2108160" cy="9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28099080" y="16497000"/>
                <a:ext cx="21081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20818440" y="17233560"/>
                <a:ext cx="129780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2500" spc="-1" strike="noStrike">
                    <a:solidFill>
                      <a:srgbClr val="000000"/>
                    </a:solidFill>
                    <a:latin typeface="Garamond"/>
                  </a:rPr>
                  <a:t>Balance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21933720" y="17233560"/>
                <a:ext cx="225792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Only (n = 572)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24153840" y="1723356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26576280" y="17233560"/>
                <a:ext cx="9104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90.9%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27452520" y="1723356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28685880" y="17233560"/>
                <a:ext cx="9104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49.0%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9563920" y="1723356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20818800" y="17222400"/>
                <a:ext cx="5167080" cy="9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20818800" y="17222400"/>
                <a:ext cx="5167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25985880" y="17222400"/>
                <a:ext cx="9720" cy="9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25985880" y="17222400"/>
                <a:ext cx="9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25985880" y="17222400"/>
                <a:ext cx="1800" cy="9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25995600" y="17222400"/>
                <a:ext cx="2093760" cy="9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25995600" y="17222400"/>
                <a:ext cx="20937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28089360" y="17222400"/>
                <a:ext cx="9720" cy="9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28089360" y="17222400"/>
                <a:ext cx="9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28089360" y="17222400"/>
                <a:ext cx="1800" cy="9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28099080" y="17222400"/>
                <a:ext cx="2108160" cy="9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8099080" y="17222400"/>
                <a:ext cx="21081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20729880" y="17590680"/>
                <a:ext cx="295740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2500" spc="-1" strike="noStrike">
                    <a:solidFill>
                      <a:srgbClr val="000000"/>
                    </a:solidFill>
                    <a:latin typeface="Garamond"/>
                  </a:rPr>
                  <a:t>Balance + Nourish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23524560" y="17590680"/>
                <a:ext cx="14198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(n = 596)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24927120" y="1759068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26576280" y="17590680"/>
                <a:ext cx="9104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19.1%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27430560" y="1759068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28778400" y="17590680"/>
                <a:ext cx="73368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8.1%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29476800" y="1759068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20739600" y="17949600"/>
                <a:ext cx="289008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2500" spc="-1" strike="noStrike">
                    <a:solidFill>
                      <a:srgbClr val="000000"/>
                    </a:solidFill>
                    <a:latin typeface="Garamond"/>
                  </a:rPr>
                  <a:t>Balance + Achieve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23473800" y="17949600"/>
                <a:ext cx="14198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(n = 584)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24877800" y="1794960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26576280" y="17949600"/>
                <a:ext cx="9104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62.2%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27452520" y="1794960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28685880" y="17949600"/>
                <a:ext cx="9104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25.3%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29563920" y="1794960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20573280" y="18306720"/>
                <a:ext cx="470700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All of the Above Combined (n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25046640" y="18306720"/>
                <a:ext cx="83448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=559)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25878600" y="1830672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20927880" y="1866564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26575560" y="18306720"/>
                <a:ext cx="9104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13.4%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27441720" y="1830672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28777680" y="18306720"/>
                <a:ext cx="73368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5.7%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29486160" y="1830672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20915280" y="19014840"/>
                <a:ext cx="1072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500" spc="-1" strike="noStrike">
                    <a:solidFill>
                      <a:srgbClr val="000000"/>
                    </a:solidFill>
                    <a:latin typeface="Garamond"/>
                  </a:rPr>
                  <a:t>1</a:t>
                </a:r>
                <a:endParaRPr b="0" lang="en-US" sz="1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21004200" y="1903212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20719800" y="19032120"/>
                <a:ext cx="570492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Initial Engagement = Viewed initial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26071920" y="19032120"/>
                <a:ext cx="170460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electronic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27592560" y="19032120"/>
                <a:ext cx="11253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guides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20928600" y="1938960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20683080" y="19389600"/>
                <a:ext cx="47084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appropriate to that condition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25109640" y="1938960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20818800" y="19021320"/>
                <a:ext cx="5167080" cy="93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20818800" y="19021320"/>
                <a:ext cx="5167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25985880" y="19021320"/>
                <a:ext cx="9720" cy="93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25985880" y="19021320"/>
                <a:ext cx="97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25985880" y="19021320"/>
                <a:ext cx="1800" cy="9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25995600" y="19021320"/>
                <a:ext cx="2093760" cy="93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25995600" y="19021320"/>
                <a:ext cx="20937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28089360" y="19021320"/>
                <a:ext cx="9720" cy="93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28089360" y="19021320"/>
                <a:ext cx="97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28089360" y="19021320"/>
                <a:ext cx="1800" cy="9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28099080" y="19021320"/>
                <a:ext cx="2108160" cy="93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28099080" y="19021320"/>
                <a:ext cx="210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20919240" y="19730880"/>
                <a:ext cx="1576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500" spc="-1" strike="noStrike">
                    <a:solidFill>
                      <a:srgbClr val="000000"/>
                    </a:solidFill>
                    <a:latin typeface="Garamond"/>
                  </a:rPr>
                  <a:t>2 </a:t>
                </a:r>
                <a:endParaRPr b="0" lang="en-US" sz="1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21070440" y="19730880"/>
                <a:ext cx="5112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1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20472840" y="19748160"/>
                <a:ext cx="912960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Ongoing Engagement = Above plus viewed at least initial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20928600" y="2010528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21016440" y="20105280"/>
                <a:ext cx="101412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follow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21967200" y="20105280"/>
                <a:ext cx="9828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-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22037760" y="20105280"/>
                <a:ext cx="4989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up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22365360" y="20105280"/>
                <a:ext cx="170460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electronic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23310360" y="20105280"/>
                <a:ext cx="714672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newsletters appropriate to condition (or for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20927880" y="2046420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21022200" y="20464200"/>
                <a:ext cx="125208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2500" spc="-1" strike="noStrike">
                    <a:solidFill>
                      <a:srgbClr val="000000"/>
                    </a:solidFill>
                    <a:latin typeface="Garamond"/>
                  </a:rPr>
                  <a:t>Achieve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22212000" y="20464200"/>
                <a:ext cx="1760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,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22073400" y="20464200"/>
                <a:ext cx="365544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at least set initial goal)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25525440" y="2046420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25606440" y="20464200"/>
                <a:ext cx="83160" cy="381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500" spc="-1" strike="noStrike">
                    <a:solidFill>
                      <a:srgbClr val="000000"/>
                    </a:solidFill>
                    <a:latin typeface="Garamond"/>
                  </a:rPr>
                  <a:t> </a:t>
                </a:r>
                <a:endParaRPr b="0" lang="en-US" sz="25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21070440" y="20823120"/>
                <a:ext cx="61560" cy="289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9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endParaRPr b="0" lang="en-US" sz="1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0-02-09T15:01:13Z</dcterms:created>
  <dc:creator>Jay Buckley</dc:creator>
  <dc:description>Call if we can help   800-590-7850
(c)  MegaPrint Inc. 2001</dc:description>
  <dc:language>en-US</dc:language>
  <cp:lastModifiedBy>KP_User</cp:lastModifiedBy>
  <cp:lastPrinted>2000-08-03T00:31:24Z</cp:lastPrinted>
  <dcterms:modified xsi:type="dcterms:W3CDTF">2006-08-18T22:23:57Z</dcterms:modified>
  <cp:revision>77</cp:revision>
  <dc:subject/>
  <dc:title>36x72 poster template</dc:title>
</cp:coreProperties>
</file>